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693C14-1815-48CC-B785-D7C3A0F039D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12B0948B-05CD-4D3E-BBA3-2E276F33EB2B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419DD-62C0-425F-BE23-46C3864F36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4727E-930F-430E-8B59-90CE4B1DCD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F6AD3-71AD-48B2-A96C-1FBB8B2990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CC474-2E6F-4B63-BE15-802B05F5B4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C6EF5-6D0A-4CE1-9846-92ED069B55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AC2FE-4E8E-4AC2-931C-D5ED5DD6E0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68F05-CE5D-4683-9BBA-3B5FCD6189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A9D31-ADB6-4107-A8C7-B8448A7EAD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22365-2F8E-4B5F-9238-32B3EB762E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99AB2-FC9B-44B2-8BF1-DE82743327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93EA3-EFCF-4240-AD19-1278986AC2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F26ED-5D53-457C-9E46-9A4B94A877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49208B-BAC0-4D06-B870-6B51EF2D4B9B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4"/>
          <p:cNvSpPr/>
          <p:nvPr/>
        </p:nvSpPr>
        <p:spPr>
          <a:xfrm>
            <a:off x="1096920" y="4443480"/>
            <a:ext cx="460440" cy="252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43"/>
          <p:cNvSpPr/>
          <p:nvPr/>
        </p:nvSpPr>
        <p:spPr>
          <a:xfrm>
            <a:off x="4522680" y="1471680"/>
            <a:ext cx="912960" cy="438120"/>
          </a:xfrm>
          <a:prstGeom prst="rect">
            <a:avLst/>
          </a:prstGeom>
          <a:solidFill>
            <a:srgbClr val="ffffff"/>
          </a:solidFill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7680" rIns="67680" tIns="33840" bIns="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MS PGothic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MS PGothic"/>
              </a:rPr>
              <a:t>5.1%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MS PGothic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MS PGothic"/>
              </a:rPr>
              <a:t>(407/7949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4361"/>
          <p:cNvSpPr/>
          <p:nvPr/>
        </p:nvSpPr>
        <p:spPr>
          <a:xfrm>
            <a:off x="11295000" y="4021200"/>
            <a:ext cx="16668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73"/>
          <p:cNvSpPr/>
          <p:nvPr/>
        </p:nvSpPr>
        <p:spPr>
          <a:xfrm>
            <a:off x="1015920" y="4498920"/>
            <a:ext cx="568440" cy="246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82800" rIns="82800" tIns="41400" bIns="414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2" name="Connecteur droit avec flèche 22"/>
          <p:cNvCxnSpPr>
            <a:stCxn id="53" idx="2"/>
          </p:cNvCxnSpPr>
          <p:nvPr/>
        </p:nvCxnSpPr>
        <p:spPr>
          <a:xfrm>
            <a:off x="6013440" y="833760"/>
            <a:ext cx="8640" cy="1684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4" name="Rectangle 83"/>
          <p:cNvSpPr/>
          <p:nvPr/>
        </p:nvSpPr>
        <p:spPr>
          <a:xfrm>
            <a:off x="6659640" y="2678040"/>
            <a:ext cx="473040" cy="246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7680" rIns="67680" tIns="33840" bIns="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oupe 2"/>
          <p:cNvGrpSpPr/>
          <p:nvPr/>
        </p:nvGrpSpPr>
        <p:grpSpPr>
          <a:xfrm>
            <a:off x="611280" y="35640"/>
            <a:ext cx="8362800" cy="5344560"/>
            <a:chOff x="611280" y="35640"/>
            <a:chExt cx="8362800" cy="5344560"/>
          </a:xfrm>
        </p:grpSpPr>
        <p:grpSp>
          <p:nvGrpSpPr>
            <p:cNvPr id="56" name="Group 15"/>
            <p:cNvGrpSpPr/>
            <p:nvPr/>
          </p:nvGrpSpPr>
          <p:grpSpPr>
            <a:xfrm>
              <a:off x="611280" y="2163240"/>
              <a:ext cx="4176720" cy="3216960"/>
              <a:chOff x="611280" y="2163240"/>
              <a:chExt cx="4176720" cy="3216960"/>
            </a:xfrm>
          </p:grpSpPr>
          <p:sp>
            <p:nvSpPr>
              <p:cNvPr id="57" name="ZoneTexte 16"/>
              <p:cNvSpPr/>
              <p:nvPr/>
            </p:nvSpPr>
            <p:spPr>
              <a:xfrm>
                <a:off x="2681280" y="2163240"/>
                <a:ext cx="1674720" cy="326520"/>
              </a:xfrm>
              <a:prstGeom prst="rect">
                <a:avLst/>
              </a:prstGeom>
              <a:solidFill>
                <a:srgbClr val="d9d9d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2800" rIns="82800" tIns="41400" bIns="414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600" spc="-1" strike="noStrike">
                    <a:solidFill>
                      <a:srgbClr val="000000"/>
                    </a:solidFill>
                    <a:latin typeface="Calibri"/>
                  </a:rPr>
                  <a:t>Praevia placenta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ZoneTexte 20"/>
              <p:cNvSpPr/>
              <p:nvPr/>
            </p:nvSpPr>
            <p:spPr>
              <a:xfrm>
                <a:off x="1089000" y="4005000"/>
                <a:ext cx="1609560" cy="326520"/>
              </a:xfrm>
              <a:prstGeom prst="rect">
                <a:avLst/>
              </a:prstGeom>
              <a:solidFill>
                <a:srgbClr val="d9d9d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2800" rIns="82800" tIns="41400" bIns="414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600" spc="-1" strike="noStrike">
                    <a:solidFill>
                      <a:srgbClr val="000000"/>
                    </a:solidFill>
                    <a:latin typeface="Calibri"/>
                  </a:rPr>
                  <a:t>Nulliparous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9" name="Group 14363"/>
              <p:cNvGrpSpPr/>
              <p:nvPr/>
            </p:nvGrpSpPr>
            <p:grpSpPr>
              <a:xfrm>
                <a:off x="611280" y="4338720"/>
                <a:ext cx="1187640" cy="1041480"/>
                <a:chOff x="611280" y="4338720"/>
                <a:chExt cx="1187640" cy="1041480"/>
              </a:xfrm>
            </p:grpSpPr>
            <p:sp>
              <p:nvSpPr>
                <p:cNvPr id="60" name="Rectangle 229"/>
                <p:cNvSpPr/>
                <p:nvPr/>
              </p:nvSpPr>
              <p:spPr>
                <a:xfrm>
                  <a:off x="611280" y="4942080"/>
                  <a:ext cx="889200" cy="4381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3.7%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(127/3420)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Rectangle 139"/>
                <p:cNvSpPr/>
                <p:nvPr/>
              </p:nvSpPr>
              <p:spPr>
                <a:xfrm>
                  <a:off x="1208160" y="4338720"/>
                  <a:ext cx="590760" cy="24264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alibri"/>
                    </a:rPr>
                    <a:t>N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2" name="ZoneTexte 18"/>
              <p:cNvSpPr/>
              <p:nvPr/>
            </p:nvSpPr>
            <p:spPr>
              <a:xfrm>
                <a:off x="1835280" y="3069720"/>
                <a:ext cx="1689120" cy="311400"/>
              </a:xfrm>
              <a:prstGeom prst="rect">
                <a:avLst/>
              </a:prstGeom>
              <a:solidFill>
                <a:srgbClr val="d9d9d9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7680" rIns="67680" tIns="33840" bIns="3384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600" spc="-1" strike="noStrike">
                    <a:solidFill>
                      <a:srgbClr val="000000"/>
                    </a:solidFill>
                    <a:latin typeface="Calibri"/>
                  </a:rPr>
                  <a:t>Macrosomia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Rectangle 226"/>
              <p:cNvSpPr/>
              <p:nvPr/>
            </p:nvSpPr>
            <p:spPr>
              <a:xfrm>
                <a:off x="3899160" y="3098520"/>
                <a:ext cx="888840" cy="403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7680" rIns="67680" tIns="33840" bIns="338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23.9%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</a:rPr>
                  <a:t>(16/67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ZoneTexte 17"/>
              <p:cNvSpPr/>
              <p:nvPr/>
            </p:nvSpPr>
            <p:spPr>
              <a:xfrm>
                <a:off x="2684520" y="2515680"/>
                <a:ext cx="815760" cy="524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7680" rIns="67680" tIns="33840" bIns="3384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NO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Calibri"/>
                  </a:rPr>
                  <a:t>5.0%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</a:rPr>
                  <a:t>(391/7882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ZoneTexte 19"/>
              <p:cNvSpPr/>
              <p:nvPr/>
            </p:nvSpPr>
            <p:spPr>
              <a:xfrm>
                <a:off x="1919160" y="3357360"/>
                <a:ext cx="890640" cy="540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2800" rIns="82800" tIns="41400" bIns="414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NO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Calibri"/>
                  </a:rPr>
                  <a:t>4.4%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</a:rPr>
                  <a:t>(293/6594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" name="Rectangle 50"/>
            <p:cNvSpPr/>
            <p:nvPr/>
          </p:nvSpPr>
          <p:spPr>
            <a:xfrm>
              <a:off x="4289400" y="35640"/>
              <a:ext cx="3448080" cy="798120"/>
            </a:xfrm>
            <a:prstGeom prst="rect">
              <a:avLst/>
            </a:prstGeom>
            <a:solidFill>
              <a:srgbClr val="bfbfbf"/>
            </a:solidFill>
            <a:ln w="0">
              <a:noFill/>
            </a:ln>
            <a:effectLst>
              <a:outerShdw dist="20160" dir="5400000" blurRad="0" rotWithShape="0">
                <a:srgbClr val="80808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67680" rIns="67680" tIns="33840" bIns="3384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vere acute maternal morbidity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5.9% 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523/8804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ZoneTexte 8"/>
            <p:cNvSpPr/>
            <p:nvPr/>
          </p:nvSpPr>
          <p:spPr>
            <a:xfrm>
              <a:off x="4568760" y="1001520"/>
              <a:ext cx="2904840" cy="311400"/>
            </a:xfrm>
            <a:prstGeom prst="rect">
              <a:avLst/>
            </a:prstGeom>
            <a:solidFill>
              <a:srgbClr val="d9d9d9"/>
            </a:solidFill>
            <a:ln w="0">
              <a:noFill/>
            </a:ln>
            <a:effectLst>
              <a:outerShdw dist="20160" dir="5400000" blurRad="0" rotWithShape="0">
                <a:srgbClr val="80808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67680" rIns="67680" tIns="33840" bIns="3384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n-severe preeclampsi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7" name="Connecteur en angle 14337"/>
            <p:cNvCxnSpPr/>
            <p:nvPr/>
          </p:nvCxnSpPr>
          <p:spPr>
            <a:xfrm>
              <a:off x="7476840" y="1737720"/>
              <a:ext cx="1067400" cy="410040"/>
            </a:xfrm>
            <a:prstGeom prst="bentConnector2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8" name="Rectangle 211"/>
            <p:cNvSpPr/>
            <p:nvPr/>
          </p:nvSpPr>
          <p:spPr>
            <a:xfrm>
              <a:off x="6732720" y="1504800"/>
              <a:ext cx="784080" cy="466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7680" rIns="67680" tIns="33840" bIns="338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YE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223"/>
            <p:cNvSpPr/>
            <p:nvPr/>
          </p:nvSpPr>
          <p:spPr>
            <a:xfrm>
              <a:off x="8083800" y="2192400"/>
              <a:ext cx="890280" cy="4381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67680" rIns="67680" tIns="33840" bIns="338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13.6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(116/855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238"/>
            <p:cNvSpPr/>
            <p:nvPr/>
          </p:nvSpPr>
          <p:spPr>
            <a:xfrm>
              <a:off x="5415120" y="1725480"/>
              <a:ext cx="1317600" cy="12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240"/>
            <p:cNvSpPr/>
            <p:nvPr/>
          </p:nvSpPr>
          <p:spPr>
            <a:xfrm flipH="1">
              <a:off x="6014880" y="1315800"/>
              <a:ext cx="6120" cy="404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Rectangle 1"/>
          <p:cNvSpPr/>
          <p:nvPr/>
        </p:nvSpPr>
        <p:spPr>
          <a:xfrm>
            <a:off x="19080" y="115920"/>
            <a:ext cx="388764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1 Fig. Classification and regression tree analysis: Factors present at the beginning and arising during pregnancy, sensitivity analysis after exclusion of women with severe acute maternal morbidity only due to hypertensive complication (19 cases), JUMODA cohort (n=8804 women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43"/>
          <p:cNvSpPr/>
          <p:nvPr/>
        </p:nvSpPr>
        <p:spPr>
          <a:xfrm>
            <a:off x="3132000" y="3860640"/>
            <a:ext cx="863640" cy="438480"/>
          </a:xfrm>
          <a:prstGeom prst="rect">
            <a:avLst/>
          </a:prstGeom>
          <a:noFill/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7680" rIns="67680" tIns="33840" bIns="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7.6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(98/1288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ZoneTexte 64"/>
          <p:cNvSpPr/>
          <p:nvPr/>
        </p:nvSpPr>
        <p:spPr>
          <a:xfrm>
            <a:off x="1908000" y="4971960"/>
            <a:ext cx="1609920" cy="3265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800" rIns="82800" tIns="41400" bIns="41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Calibri"/>
              </a:rPr>
              <a:t>Sub-Sahara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71"/>
          <p:cNvSpPr/>
          <p:nvPr/>
        </p:nvSpPr>
        <p:spPr>
          <a:xfrm>
            <a:off x="1476360" y="5950080"/>
            <a:ext cx="888840" cy="438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5.1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(157/3073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72"/>
          <p:cNvSpPr/>
          <p:nvPr/>
        </p:nvSpPr>
        <p:spPr>
          <a:xfrm>
            <a:off x="3110040" y="6066000"/>
            <a:ext cx="957240" cy="242640"/>
          </a:xfrm>
          <a:prstGeom prst="rect">
            <a:avLst/>
          </a:prstGeom>
          <a:noFill/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8.9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9/101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7" name="Connecteur en angle 51"/>
          <p:cNvCxnSpPr/>
          <p:nvPr/>
        </p:nvCxnSpPr>
        <p:spPr>
          <a:xfrm flipV="1" rot="10800000">
            <a:off x="3499560" y="1722240"/>
            <a:ext cx="1067760" cy="410040"/>
          </a:xfrm>
          <a:prstGeom prst="bentConnector2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8" name="Connecteur en angle 74"/>
          <p:cNvCxnSpPr/>
          <p:nvPr/>
        </p:nvCxnSpPr>
        <p:spPr>
          <a:xfrm>
            <a:off x="3517560" y="2687760"/>
            <a:ext cx="826200" cy="40536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9" name="Connecteur en angle 75"/>
          <p:cNvCxnSpPr/>
          <p:nvPr/>
        </p:nvCxnSpPr>
        <p:spPr>
          <a:xfrm flipV="1" rot="10800000">
            <a:off x="2693160" y="2687400"/>
            <a:ext cx="824760" cy="40536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0" name="Connecteur droit 26"/>
          <p:cNvSpPr/>
          <p:nvPr/>
        </p:nvSpPr>
        <p:spPr>
          <a:xfrm>
            <a:off x="3500280" y="2492280"/>
            <a:ext cx="0" cy="185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76"/>
          <p:cNvSpPr/>
          <p:nvPr/>
        </p:nvSpPr>
        <p:spPr>
          <a:xfrm>
            <a:off x="3635280" y="2565360"/>
            <a:ext cx="53028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7680" rIns="67680" tIns="33840" bIns="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Connecteur droit 2"/>
          <p:cNvSpPr/>
          <p:nvPr/>
        </p:nvSpPr>
        <p:spPr>
          <a:xfrm>
            <a:off x="2819520" y="2678040"/>
            <a:ext cx="52848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3" name="Connecteur en angle 52"/>
          <p:cNvCxnSpPr/>
          <p:nvPr/>
        </p:nvCxnSpPr>
        <p:spPr>
          <a:xfrm>
            <a:off x="2715840" y="3578400"/>
            <a:ext cx="824760" cy="40536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4" name="Connecteur en angle 53"/>
          <p:cNvCxnSpPr/>
          <p:nvPr/>
        </p:nvCxnSpPr>
        <p:spPr>
          <a:xfrm flipV="1" rot="10800000">
            <a:off x="1890000" y="3578040"/>
            <a:ext cx="826200" cy="40536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5" name="Connecteur droit 54"/>
          <p:cNvSpPr/>
          <p:nvPr/>
        </p:nvSpPr>
        <p:spPr>
          <a:xfrm>
            <a:off x="2698920" y="3382920"/>
            <a:ext cx="0" cy="184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55"/>
          <p:cNvSpPr/>
          <p:nvPr/>
        </p:nvSpPr>
        <p:spPr>
          <a:xfrm>
            <a:off x="2833560" y="3454560"/>
            <a:ext cx="52884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7680" rIns="67680" tIns="33840" bIns="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Connecteur droit 56"/>
          <p:cNvSpPr/>
          <p:nvPr/>
        </p:nvSpPr>
        <p:spPr>
          <a:xfrm>
            <a:off x="2016000" y="3567240"/>
            <a:ext cx="52884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8" name="Connecteur en angle 61"/>
          <p:cNvCxnSpPr/>
          <p:nvPr/>
        </p:nvCxnSpPr>
        <p:spPr>
          <a:xfrm>
            <a:off x="1908000" y="4535640"/>
            <a:ext cx="826560" cy="40680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9" name="Connecteur en angle 62"/>
          <p:cNvCxnSpPr/>
          <p:nvPr/>
        </p:nvCxnSpPr>
        <p:spPr>
          <a:xfrm flipV="1" rot="10800000">
            <a:off x="1083600" y="4535280"/>
            <a:ext cx="824400" cy="40680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0" name="Connecteur droit 63"/>
          <p:cNvSpPr/>
          <p:nvPr/>
        </p:nvSpPr>
        <p:spPr>
          <a:xfrm>
            <a:off x="1890720" y="4341960"/>
            <a:ext cx="0" cy="183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77"/>
          <p:cNvSpPr/>
          <p:nvPr/>
        </p:nvSpPr>
        <p:spPr>
          <a:xfrm>
            <a:off x="1943280" y="4365720"/>
            <a:ext cx="757080" cy="57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7680" rIns="67680" tIns="33840" bIns="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5.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(166/3174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Connecteur droit 11"/>
          <p:cNvSpPr/>
          <p:nvPr/>
        </p:nvSpPr>
        <p:spPr>
          <a:xfrm>
            <a:off x="1201680" y="4543560"/>
            <a:ext cx="59076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3" name="Connecteur en angle 106"/>
          <p:cNvCxnSpPr/>
          <p:nvPr/>
        </p:nvCxnSpPr>
        <p:spPr>
          <a:xfrm>
            <a:off x="2749680" y="5509800"/>
            <a:ext cx="824400" cy="40572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94" name="Connecteur en angle 107"/>
          <p:cNvCxnSpPr/>
          <p:nvPr/>
        </p:nvCxnSpPr>
        <p:spPr>
          <a:xfrm flipV="1" rot="10800000">
            <a:off x="1923480" y="5509800"/>
            <a:ext cx="826200" cy="405720"/>
          </a:xfrm>
          <a:prstGeom prst="bentConnector3">
            <a:avLst>
              <a:gd name="adj1" fmla="val 100087"/>
            </a:avLst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5" name="Connecteur droit 109"/>
          <p:cNvSpPr/>
          <p:nvPr/>
        </p:nvSpPr>
        <p:spPr>
          <a:xfrm>
            <a:off x="2732040" y="5332320"/>
            <a:ext cx="0" cy="184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Connecteur droit 112"/>
          <p:cNvSpPr/>
          <p:nvPr/>
        </p:nvSpPr>
        <p:spPr>
          <a:xfrm>
            <a:off x="2041560" y="5516640"/>
            <a:ext cx="59040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113"/>
          <p:cNvSpPr/>
          <p:nvPr/>
        </p:nvSpPr>
        <p:spPr>
          <a:xfrm>
            <a:off x="2036880" y="5373720"/>
            <a:ext cx="590400" cy="2430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114"/>
          <p:cNvSpPr/>
          <p:nvPr/>
        </p:nvSpPr>
        <p:spPr>
          <a:xfrm>
            <a:off x="2843280" y="5383080"/>
            <a:ext cx="590400" cy="2430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6T12:04:26Z</dcterms:created>
  <dc:creator>d k</dc:creator>
  <dc:description/>
  <cp:keywords/>
  <dc:language>en-US</dc:language>
  <cp:lastModifiedBy>KORB D</cp:lastModifiedBy>
  <dcterms:modified xsi:type="dcterms:W3CDTF">2020-02-14T17:59:24Z</dcterms:modified>
  <cp:revision>8</cp:revision>
  <dc:subject/>
  <dc:title>PowerPoint Presentation</dc:title>
</cp:coreProperties>
</file>